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7" r:id="rId2"/>
  </p:sldIdLst>
  <p:sldSz cx="9039225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200" d="100"/>
          <a:sy n="200" d="100"/>
        </p:scale>
        <p:origin x="-1736" y="-16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29903" y="765909"/>
            <a:ext cx="6779419" cy="1629316"/>
          </a:xfrm>
        </p:spPr>
        <p:txBody>
          <a:bodyPr anchor="b"/>
          <a:lstStyle>
            <a:lvl1pPr algn="ctr">
              <a:defRPr sz="40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9903" y="2458058"/>
            <a:ext cx="6779419" cy="1129904"/>
          </a:xfrm>
        </p:spPr>
        <p:txBody>
          <a:bodyPr/>
          <a:lstStyle>
            <a:lvl1pPr marL="0" indent="0" algn="ctr">
              <a:buNone/>
              <a:defRPr sz="1638"/>
            </a:lvl1pPr>
            <a:lvl2pPr marL="311993" indent="0" algn="ctr">
              <a:buNone/>
              <a:defRPr sz="1365"/>
            </a:lvl2pPr>
            <a:lvl3pPr marL="623987" indent="0" algn="ctr">
              <a:buNone/>
              <a:defRPr sz="1228"/>
            </a:lvl3pPr>
            <a:lvl4pPr marL="935980" indent="0" algn="ctr">
              <a:buNone/>
              <a:defRPr sz="1092"/>
            </a:lvl4pPr>
            <a:lvl5pPr marL="1247973" indent="0" algn="ctr">
              <a:buNone/>
              <a:defRPr sz="1092"/>
            </a:lvl5pPr>
            <a:lvl6pPr marL="1559966" indent="0" algn="ctr">
              <a:buNone/>
              <a:defRPr sz="1092"/>
            </a:lvl6pPr>
            <a:lvl7pPr marL="1871960" indent="0" algn="ctr">
              <a:buNone/>
              <a:defRPr sz="1092"/>
            </a:lvl7pPr>
            <a:lvl8pPr marL="2183953" indent="0" algn="ctr">
              <a:buNone/>
              <a:defRPr sz="1092"/>
            </a:lvl8pPr>
            <a:lvl9pPr marL="2495946" indent="0" algn="ctr">
              <a:buNone/>
              <a:defRPr sz="109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340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897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68695" y="249164"/>
            <a:ext cx="1949083" cy="39660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1447" y="249164"/>
            <a:ext cx="5734258" cy="39660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099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744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6739" y="1166738"/>
            <a:ext cx="7796332" cy="1946729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6739" y="3131884"/>
            <a:ext cx="7796332" cy="1023739"/>
          </a:xfrm>
        </p:spPr>
        <p:txBody>
          <a:bodyPr/>
          <a:lstStyle>
            <a:lvl1pPr marL="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1pPr>
            <a:lvl2pPr marL="311993" indent="0">
              <a:buNone/>
              <a:defRPr sz="1365">
                <a:solidFill>
                  <a:schemeClr val="tx1">
                    <a:tint val="75000"/>
                  </a:schemeClr>
                </a:solidFill>
              </a:defRPr>
            </a:lvl2pPr>
            <a:lvl3pPr marL="62398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3pPr>
            <a:lvl4pPr marL="93598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4pPr>
            <a:lvl5pPr marL="124797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5pPr>
            <a:lvl6pPr marL="155996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6pPr>
            <a:lvl7pPr marL="187196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7pPr>
            <a:lvl8pPr marL="218395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8pPr>
            <a:lvl9pPr marL="249594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585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1447" y="1245820"/>
            <a:ext cx="3841671" cy="29693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6107" y="1245820"/>
            <a:ext cx="3841671" cy="29693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569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2624" y="249164"/>
            <a:ext cx="7796332" cy="9045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2624" y="1147238"/>
            <a:ext cx="3824016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2624" y="1709482"/>
            <a:ext cx="3824016" cy="2514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6108" y="1147238"/>
            <a:ext cx="3842848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76108" y="1709482"/>
            <a:ext cx="3842848" cy="2514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948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544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383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2624" y="311997"/>
            <a:ext cx="2915385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42848" y="673826"/>
            <a:ext cx="4576108" cy="3325798"/>
          </a:xfrm>
        </p:spPr>
        <p:txBody>
          <a:bodyPr/>
          <a:lstStyle>
            <a:lvl1pPr>
              <a:defRPr sz="2184"/>
            </a:lvl1pPr>
            <a:lvl2pPr>
              <a:defRPr sz="1911"/>
            </a:lvl2pPr>
            <a:lvl3pPr>
              <a:defRPr sz="1638"/>
            </a:lvl3pPr>
            <a:lvl4pPr>
              <a:defRPr sz="1365"/>
            </a:lvl4pPr>
            <a:lvl5pPr>
              <a:defRPr sz="1365"/>
            </a:lvl5pPr>
            <a:lvl6pPr>
              <a:defRPr sz="1365"/>
            </a:lvl6pPr>
            <a:lvl7pPr>
              <a:defRPr sz="1365"/>
            </a:lvl7pPr>
            <a:lvl8pPr>
              <a:defRPr sz="1365"/>
            </a:lvl8pPr>
            <a:lvl9pPr>
              <a:defRPr sz="136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2624" y="1403985"/>
            <a:ext cx="2915385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073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2624" y="311997"/>
            <a:ext cx="2915385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42848" y="673826"/>
            <a:ext cx="4576108" cy="3325798"/>
          </a:xfrm>
        </p:spPr>
        <p:txBody>
          <a:bodyPr anchor="t"/>
          <a:lstStyle>
            <a:lvl1pPr marL="0" indent="0">
              <a:buNone/>
              <a:defRPr sz="2184"/>
            </a:lvl1pPr>
            <a:lvl2pPr marL="311993" indent="0">
              <a:buNone/>
              <a:defRPr sz="1911"/>
            </a:lvl2pPr>
            <a:lvl3pPr marL="623987" indent="0">
              <a:buNone/>
              <a:defRPr sz="1638"/>
            </a:lvl3pPr>
            <a:lvl4pPr marL="935980" indent="0">
              <a:buNone/>
              <a:defRPr sz="1365"/>
            </a:lvl4pPr>
            <a:lvl5pPr marL="1247973" indent="0">
              <a:buNone/>
              <a:defRPr sz="1365"/>
            </a:lvl5pPr>
            <a:lvl6pPr marL="1559966" indent="0">
              <a:buNone/>
              <a:defRPr sz="1365"/>
            </a:lvl6pPr>
            <a:lvl7pPr marL="1871960" indent="0">
              <a:buNone/>
              <a:defRPr sz="1365"/>
            </a:lvl7pPr>
            <a:lvl8pPr marL="2183953" indent="0">
              <a:buNone/>
              <a:defRPr sz="1365"/>
            </a:lvl8pPr>
            <a:lvl9pPr marL="2495946" indent="0">
              <a:buNone/>
              <a:defRPr sz="136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2624" y="1403985"/>
            <a:ext cx="2915385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508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1447" y="249164"/>
            <a:ext cx="7796332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1447" y="1245820"/>
            <a:ext cx="7796332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1447" y="4337621"/>
            <a:ext cx="2033826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2810C-2CA9-4590-B8B7-F6A76716996E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94244" y="4337621"/>
            <a:ext cx="305073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83952" y="4337621"/>
            <a:ext cx="2033826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A504F-FBB3-40D4-8E37-35EE44126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57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23987" rtl="0" eaLnBrk="1" latinLnBrk="0" hangingPunct="1">
        <a:lnSpc>
          <a:spcPct val="90000"/>
        </a:lnSpc>
        <a:spcBef>
          <a:spcPct val="0"/>
        </a:spcBef>
        <a:buNone/>
        <a:defRPr sz="30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997" indent="-155997" algn="l" defTabSz="623987" rtl="0" eaLnBrk="1" latinLnBrk="0" hangingPunct="1">
        <a:lnSpc>
          <a:spcPct val="90000"/>
        </a:lnSpc>
        <a:spcBef>
          <a:spcPts val="682"/>
        </a:spcBef>
        <a:buFont typeface="Arial" panose="020B0604020202020204" pitchFamily="34" charset="0"/>
        <a:buChar char="•"/>
        <a:defRPr sz="1911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+mn-lt"/>
          <a:ea typeface="+mn-ea"/>
          <a:cs typeface="+mn-cs"/>
        </a:defRPr>
      </a:lvl2pPr>
      <a:lvl3pPr marL="77998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5" kern="1200">
          <a:solidFill>
            <a:schemeClr val="tx1"/>
          </a:solidFill>
          <a:latin typeface="+mn-lt"/>
          <a:ea typeface="+mn-ea"/>
          <a:cs typeface="+mn-cs"/>
        </a:defRPr>
      </a:lvl3pPr>
      <a:lvl4pPr marL="109197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71596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202795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33995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65194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1pPr>
      <a:lvl2pPr marL="31199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2pPr>
      <a:lvl3pPr marL="623987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3pPr>
      <a:lvl4pPr marL="93598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24797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55996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187196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18395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49594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E18D3E5-5565-4EDB-A096-1E06395E94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67" y="206638"/>
            <a:ext cx="2044352" cy="20124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6920D14-BAD0-437F-99DB-B4DD523719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3314" y="157625"/>
            <a:ext cx="2044352" cy="26448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FAE5EDD-837A-4605-8DF6-5DB1571934B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1071"/>
          <a:stretch/>
        </p:blipFill>
        <p:spPr>
          <a:xfrm>
            <a:off x="4259762" y="198876"/>
            <a:ext cx="2044352" cy="208757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08D1073-6E14-4ADE-B9C8-AF8E4CD472D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0641"/>
          <a:stretch/>
        </p:blipFill>
        <p:spPr>
          <a:xfrm>
            <a:off x="6411139" y="193184"/>
            <a:ext cx="2044352" cy="209895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EB6E8A9-700B-4957-ABEA-AD7799C18A38}"/>
              </a:ext>
            </a:extLst>
          </p:cNvPr>
          <p:cNvSpPr txBox="1"/>
          <p:nvPr/>
        </p:nvSpPr>
        <p:spPr>
          <a:xfrm>
            <a:off x="115996" y="48557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DCE001-93A5-4299-9FE1-2451DAC132FF}"/>
              </a:ext>
            </a:extLst>
          </p:cNvPr>
          <p:cNvSpPr txBox="1"/>
          <p:nvPr/>
        </p:nvSpPr>
        <p:spPr>
          <a:xfrm>
            <a:off x="2258265" y="48558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B44E599-4FB3-4FF4-9CD4-6A558D4E0B69}"/>
              </a:ext>
            </a:extLst>
          </p:cNvPr>
          <p:cNvSpPr txBox="1"/>
          <p:nvPr/>
        </p:nvSpPr>
        <p:spPr>
          <a:xfrm>
            <a:off x="128000" y="2219047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37EAAE6-AE6C-4C3A-A40E-60C95DA2447C}"/>
              </a:ext>
            </a:extLst>
          </p:cNvPr>
          <p:cNvSpPr txBox="1"/>
          <p:nvPr/>
        </p:nvSpPr>
        <p:spPr>
          <a:xfrm>
            <a:off x="6402781" y="48555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FF373702-CA3B-4006-BDEC-9708484F5D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440" y="2376619"/>
            <a:ext cx="2098401" cy="202093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EAA7205-A72E-45CA-811D-D66D7F3BE61F}"/>
              </a:ext>
            </a:extLst>
          </p:cNvPr>
          <p:cNvSpPr txBox="1"/>
          <p:nvPr/>
        </p:nvSpPr>
        <p:spPr>
          <a:xfrm>
            <a:off x="4334691" y="48556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C4BE3E-A398-4846-81F4-639956DD4CE6}"/>
              </a:ext>
            </a:extLst>
          </p:cNvPr>
          <p:cNvSpPr txBox="1"/>
          <p:nvPr/>
        </p:nvSpPr>
        <p:spPr>
          <a:xfrm rot="16200000">
            <a:off x="-215014" y="1013202"/>
            <a:ext cx="78539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CCR5-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374745-0D52-4195-A5EC-BCAD9D78CD2B}"/>
              </a:ext>
            </a:extLst>
          </p:cNvPr>
          <p:cNvSpPr txBox="1"/>
          <p:nvPr/>
        </p:nvSpPr>
        <p:spPr>
          <a:xfrm rot="16200000">
            <a:off x="-475548" y="3178217"/>
            <a:ext cx="12181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        Live cells-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5C2077-DAFF-4756-8F24-A0A91A0C48DC}"/>
              </a:ext>
            </a:extLst>
          </p:cNvPr>
          <p:cNvSpPr txBox="1"/>
          <p:nvPr/>
        </p:nvSpPr>
        <p:spPr>
          <a:xfrm rot="16200000">
            <a:off x="6008783" y="962218"/>
            <a:ext cx="88736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CCR1-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EAAE28E-E0E1-4EC1-9A30-FBD2941CDEF5}"/>
              </a:ext>
            </a:extLst>
          </p:cNvPr>
          <p:cNvSpPr txBox="1"/>
          <p:nvPr/>
        </p:nvSpPr>
        <p:spPr>
          <a:xfrm rot="16200000">
            <a:off x="4014360" y="1073380"/>
            <a:ext cx="70067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CCR5-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FF1747-7E1D-42D8-BDE0-CDFF187B6A50}"/>
              </a:ext>
            </a:extLst>
          </p:cNvPr>
          <p:cNvSpPr txBox="1"/>
          <p:nvPr/>
        </p:nvSpPr>
        <p:spPr>
          <a:xfrm rot="16200000">
            <a:off x="1821610" y="946095"/>
            <a:ext cx="95524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CCR1-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BA4607-8A65-40D2-B726-E8A5834B9586}"/>
              </a:ext>
            </a:extLst>
          </p:cNvPr>
          <p:cNvSpPr txBox="1"/>
          <p:nvPr/>
        </p:nvSpPr>
        <p:spPr>
          <a:xfrm>
            <a:off x="733816" y="2072500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MO CCR5 FSC-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F7E980-FD85-4ADA-BB77-46995489DC2B}"/>
              </a:ext>
            </a:extLst>
          </p:cNvPr>
          <p:cNvSpPr txBox="1"/>
          <p:nvPr/>
        </p:nvSpPr>
        <p:spPr>
          <a:xfrm>
            <a:off x="2912825" y="2065641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MO CCR1 FSC-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7D5A13-6FFE-4476-959D-34948F6CFEA5}"/>
              </a:ext>
            </a:extLst>
          </p:cNvPr>
          <p:cNvSpPr txBox="1"/>
          <p:nvPr/>
        </p:nvSpPr>
        <p:spPr>
          <a:xfrm>
            <a:off x="5205955" y="2065641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SC-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A0F3E08-E1D8-4A02-B7DB-D8D2BC4D4102}"/>
              </a:ext>
            </a:extLst>
          </p:cNvPr>
          <p:cNvSpPr txBox="1"/>
          <p:nvPr/>
        </p:nvSpPr>
        <p:spPr>
          <a:xfrm>
            <a:off x="7196818" y="2072863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SC-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B7172B1-68A5-4E36-8A29-C2063A136FD6}"/>
              </a:ext>
            </a:extLst>
          </p:cNvPr>
          <p:cNvSpPr txBox="1"/>
          <p:nvPr/>
        </p:nvSpPr>
        <p:spPr>
          <a:xfrm>
            <a:off x="923621" y="4271733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SC-A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BA4CBFC3-F4F0-401C-91D1-C59A67A0FEC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72479" y="2369574"/>
            <a:ext cx="2054836" cy="202272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78E40FF-45C1-4786-B97F-60AB5AE9999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49279" y="2376873"/>
            <a:ext cx="2054835" cy="202272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31AEDF1E-3F31-4A29-A632-03D63B84BEB5}"/>
              </a:ext>
            </a:extLst>
          </p:cNvPr>
          <p:cNvSpPr txBox="1"/>
          <p:nvPr/>
        </p:nvSpPr>
        <p:spPr>
          <a:xfrm>
            <a:off x="2243150" y="2238119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745D237-895A-4241-8D60-A9DF2FBD30AD}"/>
              </a:ext>
            </a:extLst>
          </p:cNvPr>
          <p:cNvSpPr txBox="1"/>
          <p:nvPr/>
        </p:nvSpPr>
        <p:spPr>
          <a:xfrm>
            <a:off x="4335663" y="2267993"/>
            <a:ext cx="33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FC1DA4B-0E20-49A7-B835-2C21B893D0D6}"/>
              </a:ext>
            </a:extLst>
          </p:cNvPr>
          <p:cNvSpPr txBox="1"/>
          <p:nvPr/>
        </p:nvSpPr>
        <p:spPr>
          <a:xfrm>
            <a:off x="5203134" y="4273430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SC-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4852CC-423D-4942-ADFB-9F21941BDA83}"/>
              </a:ext>
            </a:extLst>
          </p:cNvPr>
          <p:cNvSpPr txBox="1"/>
          <p:nvPr/>
        </p:nvSpPr>
        <p:spPr>
          <a:xfrm>
            <a:off x="3032883" y="4275934"/>
            <a:ext cx="136474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FSC-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031DE26-23E5-433F-9F62-60A4AF7AF866}"/>
              </a:ext>
            </a:extLst>
          </p:cNvPr>
          <p:cNvSpPr txBox="1"/>
          <p:nvPr/>
        </p:nvSpPr>
        <p:spPr>
          <a:xfrm rot="16200000">
            <a:off x="3958290" y="3138743"/>
            <a:ext cx="83377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PNA-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80712CC-D078-455E-873F-1DE839F060AF}"/>
              </a:ext>
            </a:extLst>
          </p:cNvPr>
          <p:cNvSpPr txBox="1"/>
          <p:nvPr/>
        </p:nvSpPr>
        <p:spPr>
          <a:xfrm rot="16200000">
            <a:off x="1774119" y="3078010"/>
            <a:ext cx="95524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/>
              <a:t>PNA-A</a:t>
            </a:r>
          </a:p>
        </p:txBody>
      </p:sp>
    </p:spTree>
    <p:extLst>
      <p:ext uri="{BB962C8B-B14F-4D97-AF65-F5344CB8AC3E}">
        <p14:creationId xmlns:p14="http://schemas.microsoft.com/office/powerpoint/2010/main" val="3863186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U 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Verhallen</dc:creator>
  <cp:lastModifiedBy>Lisa Verhallen</cp:lastModifiedBy>
  <cp:revision>6</cp:revision>
  <dcterms:created xsi:type="dcterms:W3CDTF">2022-10-05T08:59:38Z</dcterms:created>
  <dcterms:modified xsi:type="dcterms:W3CDTF">2022-12-14T09:36:35Z</dcterms:modified>
</cp:coreProperties>
</file>